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ags/tag1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4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251" userDrawn="1">
          <p15:clr>
            <a:srgbClr val="A4A3A4"/>
          </p15:clr>
        </p15:guide>
        <p15:guide id="2" pos="3885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刚" initials="刚" lastIdx="1" clrIdx="0">
    <p:extLst>
      <p:ext uri="{19B8F6BF-5375-455C-9EA6-DF929625EA0E}">
        <p15:presenceInfo xmlns:p15="http://schemas.microsoft.com/office/powerpoint/2012/main" userId="194db4fcde870a24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107" autoAdjust="0"/>
    <p:restoredTop sz="94660"/>
  </p:normalViewPr>
  <p:slideViewPr>
    <p:cSldViewPr snapToGrid="0" showGuides="1">
      <p:cViewPr varScale="1">
        <p:scale>
          <a:sx n="120" d="100"/>
          <a:sy n="120" d="100"/>
        </p:scale>
        <p:origin x="282" y="96"/>
      </p:cViewPr>
      <p:guideLst>
        <p:guide orient="horz" pos="2251"/>
        <p:guide pos="388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C334EAB-8CB9-4842-BFCC-82FF58BE09E1}" type="datetimeFigureOut">
              <a:rPr lang="zh-CN" altLang="en-US" smtClean="0"/>
              <a:t>2021/5/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A2303FE-57A0-4052-8E1E-E719651CF0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130101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0AACD92-2D1B-4D27-8250-7CBD87ACBCE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A685B3CC-42DE-4087-8AF5-055FB4F2905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05F5A53-EF2A-48C3-ADA4-C9B2DADDBA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8DCB9-8E6B-4E41-9812-2533EF8D4CFC}" type="datetimeFigureOut">
              <a:rPr lang="zh-CN" altLang="en-US" smtClean="0"/>
              <a:t>2021/5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6710C89-50E7-4CF5-87D8-CC0476162F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ADA8E25-3035-4347-90E9-D800B91F6A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F5156-4313-4376-B3C3-25367E6BF53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850638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F1DF640-447F-4A97-8AFC-B33BDFE5E4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923859A-15E5-451E-8780-06127D5249E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450704A-7BFA-4A9D-9D90-DB1DDE7167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8DCB9-8E6B-4E41-9812-2533EF8D4CFC}" type="datetimeFigureOut">
              <a:rPr lang="zh-CN" altLang="en-US" smtClean="0"/>
              <a:t>2021/5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F8A0707-4134-4AAC-AA16-D06C075EB2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C6636DB-F1CC-4E61-AF82-9409798811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F5156-4313-4376-B3C3-25367E6BF53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890832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67D6F4F5-8D5C-40E9-B8B6-AB7E699D4A6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BFAC5FB-02E8-4A8A-A712-E48952E2826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E6BB7BA-F0B8-4384-B94D-D6249C7844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8DCB9-8E6B-4E41-9812-2533EF8D4CFC}" type="datetimeFigureOut">
              <a:rPr lang="zh-CN" altLang="en-US" smtClean="0"/>
              <a:t>2021/5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FFF14BE-2155-47EB-A55E-531B316CDC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9187413-62E8-4405-9321-C7D0DAC4FD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F5156-4313-4376-B3C3-25367E6BF53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667248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B60C2FD-3058-4217-9048-3F4749A30E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0A7FEF6-8B15-453D-989D-300F8F14778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26348CE-4FBF-4924-B0E7-CEBE8BDDB0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8DCB9-8E6B-4E41-9812-2533EF8D4CFC}" type="datetimeFigureOut">
              <a:rPr lang="zh-CN" altLang="en-US" smtClean="0"/>
              <a:t>2021/5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64E8C9A-0CF9-4518-B1B5-4A6F660B19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A1B3992-2F8F-4337-B2E9-B5FADE33EC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F5156-4313-4376-B3C3-25367E6BF53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569709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B8075E6-29D0-4495-8D92-2580641F31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05B0760-4880-45EF-A010-7BB5E828DE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B8259B0-F74A-4F3C-9FCA-8808A28D7D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8DCB9-8E6B-4E41-9812-2533EF8D4CFC}" type="datetimeFigureOut">
              <a:rPr lang="zh-CN" altLang="en-US" smtClean="0"/>
              <a:t>2021/5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75387D5-0E97-4C8C-9184-40ECCDB7F8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28AB829-35B8-4480-B12A-B8C40082A0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F5156-4313-4376-B3C3-25367E6BF53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215579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0992491-C0F1-42C8-B862-F9B226BE47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48592E5-FDF8-4813-90AF-640B8EB0F1F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C6A8448-2397-4E34-9FDB-E3BFABAB21E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4C64333-DD81-4C4A-946B-7649FF853E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8DCB9-8E6B-4E41-9812-2533EF8D4CFC}" type="datetimeFigureOut">
              <a:rPr lang="zh-CN" altLang="en-US" smtClean="0"/>
              <a:t>2021/5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06B4371-34D9-414C-B7CD-2E19263E05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E8EF5D8-4AD1-468B-905D-66547BCA61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F5156-4313-4376-B3C3-25367E6BF53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763504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4E80600-872B-4FB9-9B23-B49858B0AE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AFE5F38-75B6-47F2-A674-76C40B5EC5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940C9FF9-B3AD-4F91-BDA7-308419C4507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7CEF2C3B-B041-4DD0-924D-37226FCE4BA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612CD32D-0522-4226-8FA7-3440E9A22B0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C7E037B7-F373-46C7-B27F-F32A127D54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8DCB9-8E6B-4E41-9812-2533EF8D4CFC}" type="datetimeFigureOut">
              <a:rPr lang="zh-CN" altLang="en-US" smtClean="0"/>
              <a:t>2021/5/7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F7E2F944-1726-402A-B2BB-C8F6B2CC01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9489F1B2-BE55-44F7-BE2A-1F7837F45C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F5156-4313-4376-B3C3-25367E6BF53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312430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2F2F3B8-7D44-4CB8-A13D-EE73859D03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2CCC4FC7-456B-4FCD-BED3-93030EB5E5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8DCB9-8E6B-4E41-9812-2533EF8D4CFC}" type="datetimeFigureOut">
              <a:rPr lang="zh-CN" altLang="en-US" smtClean="0"/>
              <a:t>2021/5/7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89F3B076-AA52-46FE-AEFE-E24B70B296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D0718EF3-B38B-4D1E-AC5F-606BE80F6A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F5156-4313-4376-B3C3-25367E6BF53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593017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302A94BC-E5D8-42A5-A5EC-7C9CA20427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8DCB9-8E6B-4E41-9812-2533EF8D4CFC}" type="datetimeFigureOut">
              <a:rPr lang="zh-CN" altLang="en-US" smtClean="0"/>
              <a:t>2021/5/7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9094416D-F0A7-4E40-A06E-E6CC66A399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DA6BCF0A-A62F-48E2-ABBA-E92858B4F7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F5156-4313-4376-B3C3-25367E6BF53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437936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7AA3FAA-049C-4B06-B033-7F957DA437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920FB16-DB3F-41BC-BBAE-DC615ED3E37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9A410B6-26F0-4D90-87EE-3D96E1B49D1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FFE2CF3-4C38-4635-92F6-21D7281794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8DCB9-8E6B-4E41-9812-2533EF8D4CFC}" type="datetimeFigureOut">
              <a:rPr lang="zh-CN" altLang="en-US" smtClean="0"/>
              <a:t>2021/5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AD07ECA-E178-4321-AFFC-E47786D947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D89001B-78E8-44C6-854D-C0FBB49982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F5156-4313-4376-B3C3-25367E6BF53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010771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6EF6FC5-FCB5-49D8-ACD8-50368D2185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16B33FC8-9D76-4726-8EB8-33B67A2F18E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2B2120C-6BCD-4334-B3ED-7B50F14F2C7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0ED41DB-7712-4F24-BB6E-1CDFF88017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8DCB9-8E6B-4E41-9812-2533EF8D4CFC}" type="datetimeFigureOut">
              <a:rPr lang="zh-CN" altLang="en-US" smtClean="0"/>
              <a:t>2021/5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437DCC3-47C6-4F07-B868-48224AC399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0411B00-D955-4A94-B604-9E4A7B7CA5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F5156-4313-4376-B3C3-25367E6BF53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22459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3D406CBA-FB76-4291-A76F-5231213783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F691487-560D-458A-A731-7B0405CE40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CA012A4-7B12-4A57-A59C-0678D7ACBB6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08DCB9-8E6B-4E41-9812-2533EF8D4CFC}" type="datetimeFigureOut">
              <a:rPr lang="zh-CN" altLang="en-US" smtClean="0"/>
              <a:t>2021/5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E10B4B3-1E97-4A83-92E3-CF3052D9840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2FF37E6-AEC6-4A05-9A10-BD05011CD88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EF5156-4313-4376-B3C3-25367E6BF53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584249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tags" Target="../tags/tag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F59CCBD1-138C-419D-AA33-4979E7AE0491}"/>
              </a:ext>
            </a:extLst>
          </p:cNvPr>
          <p:cNvGraphicFramePr/>
          <p:nvPr>
            <p:custDataLst>
              <p:tags r:id="rId1"/>
            </p:custDataLst>
            <p:extLst>
              <p:ext uri="{D42A27DB-BD31-4B8C-83A1-F6EECF244321}">
                <p14:modId xmlns:p14="http://schemas.microsoft.com/office/powerpoint/2010/main" val="4016215168"/>
              </p:ext>
            </p:extLst>
          </p:nvPr>
        </p:nvGraphicFramePr>
        <p:xfrm>
          <a:off x="1829752" y="1393870"/>
          <a:ext cx="8532496" cy="22860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42208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422083">
                  <a:extLst>
                    <a:ext uri="{9D8B030D-6E8A-4147-A177-3AD203B41FA5}">
                      <a16:colId xmlns:a16="http://schemas.microsoft.com/office/drawing/2014/main" val="3649666948"/>
                    </a:ext>
                  </a:extLst>
                </a:gridCol>
                <a:gridCol w="284416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84416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381000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mber</a:t>
                      </a:r>
                      <a:endParaRPr lang="zh-CN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sz="1800" b="1" kern="1200" dirty="0">
                          <a:solidFill>
                            <a:schemeClr val="lt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Dosage</a:t>
                      </a:r>
                      <a:endParaRPr lang="zh-CN" altLang="en-US" sz="1800" b="1" kern="1200" dirty="0">
                        <a:solidFill>
                          <a:schemeClr val="lt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ody weight (g)</a:t>
                      </a:r>
                      <a:endParaRPr lang="zh-CN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bserve for two weeks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81000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/>
                </a:tc>
                <a:tc rowSpan="5"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0 </a:t>
                      </a:r>
                    </a:p>
                    <a:p>
                      <a:pPr algn="ctr">
                        <a:buNone/>
                      </a:pPr>
                      <a:r>
                        <a:rPr lang="en-US" altLang="zh-CN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altLang="zh-CN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.p.</a:t>
                      </a:r>
                      <a:r>
                        <a:rPr lang="en-US" altLang="zh-CN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mg/kg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.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death</a:t>
                      </a:r>
                      <a:endParaRPr lang="zh-CN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81000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>
                        <a:buNone/>
                      </a:pPr>
                      <a:endParaRPr lang="en-US" altLang="zh-CN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.0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death</a:t>
                      </a:r>
                      <a:endParaRPr lang="zh-CN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81000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>
                        <a:buNone/>
                      </a:pPr>
                      <a:endParaRPr lang="en-US" altLang="zh-CN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.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death</a:t>
                      </a:r>
                      <a:endParaRPr lang="zh-CN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81000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>
                        <a:buNone/>
                      </a:pPr>
                      <a:endParaRPr lang="en-US" altLang="zh-CN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.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death</a:t>
                      </a:r>
                      <a:endParaRPr lang="zh-CN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81000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>
                        <a:buNone/>
                      </a:pPr>
                      <a:endParaRPr lang="en-US" altLang="zh-CN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.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en-US" altLang="zh-CN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death</a:t>
                      </a:r>
                      <a:endParaRPr lang="zh-CN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sp>
        <p:nvSpPr>
          <p:cNvPr id="5" name="文本框 4">
            <a:extLst>
              <a:ext uri="{FF2B5EF4-FFF2-40B4-BE49-F238E27FC236}">
                <a16:creationId xmlns:a16="http://schemas.microsoft.com/office/drawing/2014/main" id="{7E871713-F863-4472-943C-AE8DA5B1CF27}"/>
              </a:ext>
            </a:extLst>
          </p:cNvPr>
          <p:cNvSpPr txBox="1"/>
          <p:nvPr/>
        </p:nvSpPr>
        <p:spPr>
          <a:xfrm>
            <a:off x="296104" y="26041"/>
            <a:ext cx="241822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upplementary files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/>
          <p:cNvSpPr txBox="1"/>
          <p:nvPr/>
        </p:nvSpPr>
        <p:spPr>
          <a:xfrm>
            <a:off x="742950" y="714375"/>
            <a:ext cx="1072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/>
              <a:t>Table S1</a:t>
            </a:r>
            <a:endParaRPr lang="zh-CN" altLang="en-US" b="1" dirty="0"/>
          </a:p>
        </p:txBody>
      </p:sp>
    </p:spTree>
    <p:extLst>
      <p:ext uri="{BB962C8B-B14F-4D97-AF65-F5344CB8AC3E}">
        <p14:creationId xmlns:p14="http://schemas.microsoft.com/office/powerpoint/2010/main" val="793923121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ABLE_BEAUTIFY" val="smartTable{611070d0-a647-421f-bbb8-532f7897ef22}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13</TotalTime>
  <Words>41</Words>
  <Application>Microsoft Office PowerPoint</Application>
  <PresentationFormat>宽屏</PresentationFormat>
  <Paragraphs>2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刚</dc:creator>
  <cp:lastModifiedBy>PC</cp:lastModifiedBy>
  <cp:revision>81</cp:revision>
  <dcterms:created xsi:type="dcterms:W3CDTF">2021-04-21T09:08:25Z</dcterms:created>
  <dcterms:modified xsi:type="dcterms:W3CDTF">2021-05-07T02:14:48Z</dcterms:modified>
</cp:coreProperties>
</file>